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CA6E8-D678-466D-9319-3F96289837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55C013-3401-4E54-9EF8-82B2B363E92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27EF5-3F10-41CD-84C0-1638EBCD6B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D6EA5-9EE2-4278-9783-4305C1E7447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04D730-1A4C-421C-8C2B-D4F0005494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F60C2C-D902-4548-9BCC-08459F6D838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8C85E7-9FC2-44C7-A981-35AEF6540DD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04222-5169-4B98-BC8A-874AE27928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D88126-ABFE-4CAD-9C6D-A9B3606B1B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165F79-4D0D-4314-957E-511047332B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540C2-764E-474F-8638-DC47E83A3D0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1DF227-A00C-4EC1-B38A-B5FB21250E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CH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ED72E03-4360-4E6B-9BF4-D00DACEBDFA2}" type="slidenum">
              <a:rPr b="0" lang="de-CH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wmf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5"/>
          <p:cNvGrpSpPr/>
          <p:nvPr/>
        </p:nvGrpSpPr>
        <p:grpSpPr>
          <a:xfrm>
            <a:off x="220680" y="393840"/>
            <a:ext cx="8423280" cy="5749920"/>
            <a:chOff x="220680" y="393840"/>
            <a:chExt cx="8423280" cy="5749920"/>
          </a:xfrm>
        </p:grpSpPr>
        <p:sp>
          <p:nvSpPr>
            <p:cNvPr id="42" name="TextBox 4"/>
            <p:cNvSpPr/>
            <p:nvPr/>
          </p:nvSpPr>
          <p:spPr>
            <a:xfrm>
              <a:off x="259200" y="393840"/>
              <a:ext cx="355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CH" sz="1800" spc="-1" strike="noStrike">
                  <a:solidFill>
                    <a:srgbClr val="000000"/>
                  </a:solidFill>
                  <a:latin typeface="Calibri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3" name="Picture 5" descr=""/>
            <p:cNvPicPr/>
            <p:nvPr/>
          </p:nvPicPr>
          <p:blipFill>
            <a:blip r:embed="rId1"/>
            <a:stretch/>
          </p:blipFill>
          <p:spPr>
            <a:xfrm>
              <a:off x="220680" y="639720"/>
              <a:ext cx="8423280" cy="550404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7"/>
          <p:cNvGrpSpPr/>
          <p:nvPr/>
        </p:nvGrpSpPr>
        <p:grpSpPr>
          <a:xfrm>
            <a:off x="1319040" y="428760"/>
            <a:ext cx="6505920" cy="5610240"/>
            <a:chOff x="1319040" y="428760"/>
            <a:chExt cx="6505920" cy="5610240"/>
          </a:xfrm>
        </p:grpSpPr>
        <p:pic>
          <p:nvPicPr>
            <p:cNvPr id="45" name="Picture 6" descr=""/>
            <p:cNvPicPr/>
            <p:nvPr/>
          </p:nvPicPr>
          <p:blipFill>
            <a:blip r:embed="rId1"/>
            <a:stretch/>
          </p:blipFill>
          <p:spPr>
            <a:xfrm>
              <a:off x="1319040" y="428760"/>
              <a:ext cx="6505920" cy="5610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6" name="TextBox 1"/>
            <p:cNvSpPr/>
            <p:nvPr/>
          </p:nvSpPr>
          <p:spPr>
            <a:xfrm>
              <a:off x="1356840" y="487800"/>
              <a:ext cx="3571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CH" sz="1800" spc="-1" strike="noStrike">
                  <a:solidFill>
                    <a:srgbClr val="000000"/>
                  </a:solidFill>
                  <a:latin typeface="Calibri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extBox 1"/>
          <p:cNvSpPr/>
          <p:nvPr/>
        </p:nvSpPr>
        <p:spPr>
          <a:xfrm>
            <a:off x="1071720" y="785880"/>
            <a:ext cx="18396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1"/>
          <p:cNvSpPr/>
          <p:nvPr/>
        </p:nvSpPr>
        <p:spPr>
          <a:xfrm>
            <a:off x="214200" y="437040"/>
            <a:ext cx="4643640" cy="19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Additional file 1: Molecular masses and relative intensities of PrP</a:t>
            </a:r>
            <a:r>
              <a:rPr b="1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res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moieties of all animals with more than one brain region available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The investigations were conducted like written in Fig. 2. a) Average molecular masses of the unglycosylated (green), the monoglycosylated (red) and the diglycosylated band (blue) of PrP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re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are displayed with the related S.E.M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b) Average relative band intensities. The L-type (green square) is the sole sample that fell below the critical limit of 55% (dashed line). H-type is displayed as a red triangle. If available, the following brain regions were analyzed: medulla oblongata at the level of the obex (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MO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),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cerebellar cortex (CC), midbrain (MB), hippocampus (HC), parietal lobe (PL), thalamus (TH), basal ganglion (BG), cortex frontalis (CF), cortex occipitalis (CO) and cortex temporalis (CT)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1-18T09:08:21Z</dcterms:created>
  <dc:creator>tests</dc:creator>
  <dc:description/>
  <dc:language>en-US</dc:language>
  <cp:lastModifiedBy>anonymus</cp:lastModifiedBy>
  <dcterms:modified xsi:type="dcterms:W3CDTF">2009-05-12T09:49:31Z</dcterms:modified>
  <cp:revision>28</cp:revision>
  <dc:subject/>
  <dc:title>Slide 1</dc:title>
</cp:coreProperties>
</file>